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74" r:id="rId2"/>
    <p:sldId id="371" r:id="rId3"/>
    <p:sldId id="372" r:id="rId4"/>
    <p:sldId id="377" r:id="rId5"/>
    <p:sldId id="375" r:id="rId6"/>
    <p:sldId id="366" r:id="rId7"/>
    <p:sldId id="367" r:id="rId8"/>
    <p:sldId id="378" r:id="rId9"/>
  </p:sldIdLst>
  <p:sldSz cx="6218238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AEB1D"/>
    <a:srgbClr val="29AF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611" autoAdjust="0"/>
    <p:restoredTop sz="94660"/>
  </p:normalViewPr>
  <p:slideViewPr>
    <p:cSldViewPr snapToGrid="0">
      <p:cViewPr varScale="1">
        <p:scale>
          <a:sx n="85" d="100"/>
          <a:sy n="85" d="100"/>
        </p:scale>
        <p:origin x="249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8" y="1272011"/>
            <a:ext cx="5285502" cy="2705947"/>
          </a:xfrm>
        </p:spPr>
        <p:txBody>
          <a:bodyPr anchor="b"/>
          <a:lstStyle>
            <a:lvl1pPr algn="ctr">
              <a:defRPr sz="40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280" y="4082310"/>
            <a:ext cx="4663679" cy="1876530"/>
          </a:xfrm>
        </p:spPr>
        <p:txBody>
          <a:bodyPr/>
          <a:lstStyle>
            <a:lvl1pPr marL="0" indent="0" algn="ctr">
              <a:buNone/>
              <a:defRPr sz="1632"/>
            </a:lvl1pPr>
            <a:lvl2pPr marL="310896" indent="0" algn="ctr">
              <a:buNone/>
              <a:defRPr sz="1360"/>
            </a:lvl2pPr>
            <a:lvl3pPr marL="621792" indent="0" algn="ctr">
              <a:buNone/>
              <a:defRPr sz="1224"/>
            </a:lvl3pPr>
            <a:lvl4pPr marL="932688" indent="0" algn="ctr">
              <a:buNone/>
              <a:defRPr sz="1088"/>
            </a:lvl4pPr>
            <a:lvl5pPr marL="1243584" indent="0" algn="ctr">
              <a:buNone/>
              <a:defRPr sz="1088"/>
            </a:lvl5pPr>
            <a:lvl6pPr marL="1554480" indent="0" algn="ctr">
              <a:buNone/>
              <a:defRPr sz="1088"/>
            </a:lvl6pPr>
            <a:lvl7pPr marL="1865376" indent="0" algn="ctr">
              <a:buNone/>
              <a:defRPr sz="1088"/>
            </a:lvl7pPr>
            <a:lvl8pPr marL="2176272" indent="0" algn="ctr">
              <a:buNone/>
              <a:defRPr sz="1088"/>
            </a:lvl8pPr>
            <a:lvl9pPr marL="2487168" indent="0" algn="ctr">
              <a:buNone/>
              <a:defRPr sz="1088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127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205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49927" y="413808"/>
            <a:ext cx="1340808" cy="658675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504" y="413808"/>
            <a:ext cx="3944695" cy="658675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7817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7157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266" y="1937705"/>
            <a:ext cx="5363230" cy="3233102"/>
          </a:xfrm>
        </p:spPr>
        <p:txBody>
          <a:bodyPr anchor="b"/>
          <a:lstStyle>
            <a:lvl1pPr>
              <a:defRPr sz="40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266" y="5201393"/>
            <a:ext cx="5363230" cy="1700212"/>
          </a:xfrm>
        </p:spPr>
        <p:txBody>
          <a:bodyPr/>
          <a:lstStyle>
            <a:lvl1pPr marL="0" indent="0">
              <a:buNone/>
              <a:defRPr sz="1632">
                <a:solidFill>
                  <a:schemeClr val="tx1"/>
                </a:solidFill>
              </a:defRPr>
            </a:lvl1pPr>
            <a:lvl2pPr marL="31089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2pPr>
            <a:lvl3pPr marL="621792" indent="0">
              <a:buNone/>
              <a:defRPr sz="1224">
                <a:solidFill>
                  <a:schemeClr val="tx1">
                    <a:tint val="75000"/>
                  </a:schemeClr>
                </a:solidFill>
              </a:defRPr>
            </a:lvl3pPr>
            <a:lvl4pPr marL="93268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4pPr>
            <a:lvl5pPr marL="1243584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5pPr>
            <a:lvl6pPr marL="1554480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6pPr>
            <a:lvl7pPr marL="1865376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7pPr>
            <a:lvl8pPr marL="2176272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8pPr>
            <a:lvl9pPr marL="248716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326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504" y="2069042"/>
            <a:ext cx="2642751" cy="493151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7983" y="2069042"/>
            <a:ext cx="2642751" cy="493151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2360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413810"/>
            <a:ext cx="5363230" cy="150230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314" y="1905318"/>
            <a:ext cx="2630606" cy="933767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314" y="2839085"/>
            <a:ext cx="2630606" cy="41758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47983" y="1905318"/>
            <a:ext cx="2643561" cy="933767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47983" y="2839085"/>
            <a:ext cx="2643561" cy="41758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973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047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766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518160"/>
            <a:ext cx="2005544" cy="181356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3561" y="1119083"/>
            <a:ext cx="3147983" cy="5523442"/>
          </a:xfrm>
        </p:spPr>
        <p:txBody>
          <a:bodyPr/>
          <a:lstStyle>
            <a:lvl1pPr>
              <a:defRPr sz="2176"/>
            </a:lvl1pPr>
            <a:lvl2pPr>
              <a:defRPr sz="1904"/>
            </a:lvl2pPr>
            <a:lvl3pPr>
              <a:defRPr sz="1632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4" y="2331720"/>
            <a:ext cx="2005544" cy="4319800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024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518160"/>
            <a:ext cx="2005544" cy="181356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3561" y="1119083"/>
            <a:ext cx="3147983" cy="5523442"/>
          </a:xfrm>
        </p:spPr>
        <p:txBody>
          <a:bodyPr anchor="t"/>
          <a:lstStyle>
            <a:lvl1pPr marL="0" indent="0">
              <a:buNone/>
              <a:defRPr sz="2176"/>
            </a:lvl1pPr>
            <a:lvl2pPr marL="310896" indent="0">
              <a:buNone/>
              <a:defRPr sz="1904"/>
            </a:lvl2pPr>
            <a:lvl3pPr marL="621792" indent="0">
              <a:buNone/>
              <a:defRPr sz="1632"/>
            </a:lvl3pPr>
            <a:lvl4pPr marL="932688" indent="0">
              <a:buNone/>
              <a:defRPr sz="1360"/>
            </a:lvl4pPr>
            <a:lvl5pPr marL="1243584" indent="0">
              <a:buNone/>
              <a:defRPr sz="1360"/>
            </a:lvl5pPr>
            <a:lvl6pPr marL="1554480" indent="0">
              <a:buNone/>
              <a:defRPr sz="1360"/>
            </a:lvl6pPr>
            <a:lvl7pPr marL="1865376" indent="0">
              <a:buNone/>
              <a:defRPr sz="1360"/>
            </a:lvl7pPr>
            <a:lvl8pPr marL="2176272" indent="0">
              <a:buNone/>
              <a:defRPr sz="1360"/>
            </a:lvl8pPr>
            <a:lvl9pPr marL="2487168" indent="0">
              <a:buNone/>
              <a:defRPr sz="136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4" y="2331720"/>
            <a:ext cx="2005544" cy="4319800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092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7504" y="413810"/>
            <a:ext cx="536323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504" y="2069042"/>
            <a:ext cx="536323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7504" y="7203865"/>
            <a:ext cx="1399104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57313-50E8-4851-A442-5847CE03A531}" type="datetimeFigureOut">
              <a:rPr kumimoji="1" lang="ja-JP" altLang="en-US" smtClean="0"/>
              <a:t>2025/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9792" y="7203865"/>
            <a:ext cx="2098655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1630" y="7203865"/>
            <a:ext cx="1399104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DC0D3A-A500-4E9E-985B-A47BBF984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5920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1792" rtl="0" eaLnBrk="1" latinLnBrk="0" hangingPunct="1">
        <a:lnSpc>
          <a:spcPct val="90000"/>
        </a:lnSpc>
        <a:spcBef>
          <a:spcPct val="0"/>
        </a:spcBef>
        <a:buNone/>
        <a:defRPr kumimoji="1" sz="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448" indent="-155448" algn="l" defTabSz="621792" rtl="0" eaLnBrk="1" latinLnBrk="0" hangingPunct="1">
        <a:lnSpc>
          <a:spcPct val="90000"/>
        </a:lnSpc>
        <a:spcBef>
          <a:spcPts val="680"/>
        </a:spcBef>
        <a:buFont typeface="Arial" panose="020B0604020202020204" pitchFamily="34" charset="0"/>
        <a:buChar char="•"/>
        <a:defRPr kumimoji="1"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kumimoji="1" sz="1632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kumimoji="1" sz="1360" kern="1200">
          <a:solidFill>
            <a:schemeClr val="tx1"/>
          </a:solidFill>
          <a:latin typeface="+mn-lt"/>
          <a:ea typeface="+mn-ea"/>
          <a:cs typeface="+mn-cs"/>
        </a:defRPr>
      </a:lvl3pPr>
      <a:lvl4pPr marL="108813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399032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709928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202082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33172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64261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792" rtl="0" eaLnBrk="1" latinLnBrk="0" hangingPunct="1"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1pPr>
      <a:lvl2pPr marL="310896" algn="l" defTabSz="621792" rtl="0" eaLnBrk="1" latinLnBrk="0" hangingPunct="1"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2pPr>
      <a:lvl3pPr marL="621792" algn="l" defTabSz="621792" rtl="0" eaLnBrk="1" latinLnBrk="0" hangingPunct="1"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3pPr>
      <a:lvl4pPr marL="932688" algn="l" defTabSz="621792" rtl="0" eaLnBrk="1" latinLnBrk="0" hangingPunct="1"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243584" algn="l" defTabSz="621792" rtl="0" eaLnBrk="1" latinLnBrk="0" hangingPunct="1"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554480" algn="l" defTabSz="621792" rtl="0" eaLnBrk="1" latinLnBrk="0" hangingPunct="1"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1865376" algn="l" defTabSz="621792" rtl="0" eaLnBrk="1" latinLnBrk="0" hangingPunct="1"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176272" algn="l" defTabSz="621792" rtl="0" eaLnBrk="1" latinLnBrk="0" hangingPunct="1"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" algn="l" defTabSz="621792" rtl="0" eaLnBrk="1" latinLnBrk="0" hangingPunct="1">
        <a:defRPr kumimoji="1" sz="12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7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10" Type="http://schemas.openxmlformats.org/officeDocument/2006/relationships/image" Target="../media/image36.png"/><Relationship Id="rId4" Type="http://schemas.openxmlformats.org/officeDocument/2006/relationships/image" Target="../media/image30.png"/><Relationship Id="rId9" Type="http://schemas.openxmlformats.org/officeDocument/2006/relationships/image" Target="../media/image35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99B41B3-4168-A4BB-4E76-C9534E6B1445}"/>
              </a:ext>
            </a:extLst>
          </p:cNvPr>
          <p:cNvSpPr txBox="1"/>
          <p:nvPr/>
        </p:nvSpPr>
        <p:spPr>
          <a:xfrm>
            <a:off x="199308" y="7425714"/>
            <a:ext cx="28132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Black" panose="020B0A04020102020204" pitchFamily="34" charset="0"/>
              </a:rPr>
              <a:t>Supplementary Figure.1</a:t>
            </a:r>
            <a:endParaRPr lang="ja-JP" altLang="en-US" sz="1400" dirty="0">
              <a:latin typeface="Arial Black" panose="020B0A040201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CF6AF0A-E42E-91B7-9E81-36006F9A6571}"/>
              </a:ext>
            </a:extLst>
          </p:cNvPr>
          <p:cNvSpPr txBox="1"/>
          <p:nvPr/>
        </p:nvSpPr>
        <p:spPr>
          <a:xfrm>
            <a:off x="221441" y="820025"/>
            <a:ext cx="80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1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67A3EE27-FF7B-F016-4FBB-45FC445685AB}"/>
              </a:ext>
            </a:extLst>
          </p:cNvPr>
          <p:cNvSpPr/>
          <p:nvPr/>
        </p:nvSpPr>
        <p:spPr>
          <a:xfrm>
            <a:off x="2487501" y="587113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0B4FDE15-F329-D12F-F9F9-4E9441463A67}"/>
              </a:ext>
            </a:extLst>
          </p:cNvPr>
          <p:cNvSpPr/>
          <p:nvPr/>
        </p:nvSpPr>
        <p:spPr>
          <a:xfrm>
            <a:off x="2468940" y="1224028"/>
            <a:ext cx="56031" cy="1235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id="{3C38E2DB-456F-ECD1-2CA8-34FF29D3EDB9}"/>
              </a:ext>
            </a:extLst>
          </p:cNvPr>
          <p:cNvGrpSpPr/>
          <p:nvPr/>
        </p:nvGrpSpPr>
        <p:grpSpPr>
          <a:xfrm>
            <a:off x="1089302" y="314093"/>
            <a:ext cx="1457468" cy="1312680"/>
            <a:chOff x="1089302" y="314093"/>
            <a:chExt cx="1457468" cy="1312680"/>
          </a:xfrm>
        </p:grpSpPr>
        <p:pic>
          <p:nvPicPr>
            <p:cNvPr id="36" name="図 35">
              <a:extLst>
                <a:ext uri="{FF2B5EF4-FFF2-40B4-BE49-F238E27FC236}">
                  <a16:creationId xmlns:a16="http://schemas.microsoft.com/office/drawing/2014/main" id="{993E4449-E77B-072E-833F-81C5C32C369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89302" y="427590"/>
              <a:ext cx="1457468" cy="1199183"/>
            </a:xfrm>
            <a:prstGeom prst="rect">
              <a:avLst/>
            </a:prstGeom>
          </p:spPr>
        </p:pic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46C9FE5C-07C9-4AE0-49A2-9B6787BF4DAB}"/>
                </a:ext>
              </a:extLst>
            </p:cNvPr>
            <p:cNvSpPr txBox="1"/>
            <p:nvPr/>
          </p:nvSpPr>
          <p:spPr>
            <a:xfrm>
              <a:off x="1482815" y="314093"/>
              <a:ext cx="6448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1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</p:grp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139F4E8E-3201-7448-22D2-58EDE5A3674C}"/>
              </a:ext>
            </a:extLst>
          </p:cNvPr>
          <p:cNvGrpSpPr/>
          <p:nvPr/>
        </p:nvGrpSpPr>
        <p:grpSpPr>
          <a:xfrm>
            <a:off x="2650312" y="314092"/>
            <a:ext cx="1444580" cy="1307423"/>
            <a:chOff x="2650312" y="314092"/>
            <a:chExt cx="1444580" cy="1307423"/>
          </a:xfrm>
        </p:grpSpPr>
        <p:pic>
          <p:nvPicPr>
            <p:cNvPr id="43" name="図 42">
              <a:extLst>
                <a:ext uri="{FF2B5EF4-FFF2-40B4-BE49-F238E27FC236}">
                  <a16:creationId xmlns:a16="http://schemas.microsoft.com/office/drawing/2014/main" id="{36D6920E-514D-3BDB-18EE-68A291BC056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50312" y="427590"/>
              <a:ext cx="1444580" cy="1193925"/>
            </a:xfrm>
            <a:prstGeom prst="rect">
              <a:avLst/>
            </a:prstGeom>
          </p:spPr>
        </p:pic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A73DF7CF-C19F-B6C8-6661-F887A6A64665}"/>
                </a:ext>
              </a:extLst>
            </p:cNvPr>
            <p:cNvSpPr txBox="1"/>
            <p:nvPr/>
          </p:nvSpPr>
          <p:spPr>
            <a:xfrm>
              <a:off x="3012606" y="314092"/>
              <a:ext cx="728960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2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</p:grp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D5DA66F2-D30C-7C9F-83A6-00A1EEFB5DFA}"/>
              </a:ext>
            </a:extLst>
          </p:cNvPr>
          <p:cNvGrpSpPr/>
          <p:nvPr/>
        </p:nvGrpSpPr>
        <p:grpSpPr>
          <a:xfrm>
            <a:off x="4198433" y="314092"/>
            <a:ext cx="1444580" cy="1306648"/>
            <a:chOff x="4198433" y="314092"/>
            <a:chExt cx="1444580" cy="1306648"/>
          </a:xfrm>
        </p:grpSpPr>
        <p:pic>
          <p:nvPicPr>
            <p:cNvPr id="45" name="図 44">
              <a:extLst>
                <a:ext uri="{FF2B5EF4-FFF2-40B4-BE49-F238E27FC236}">
                  <a16:creationId xmlns:a16="http://schemas.microsoft.com/office/drawing/2014/main" id="{38DD4C88-5916-16B7-818D-FDF4DB8258A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98433" y="427590"/>
              <a:ext cx="1444580" cy="1193150"/>
            </a:xfrm>
            <a:prstGeom prst="rect">
              <a:avLst/>
            </a:prstGeom>
          </p:spPr>
        </p:pic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D2A97681-8E23-5140-5286-5B627A34D068}"/>
                </a:ext>
              </a:extLst>
            </p:cNvPr>
            <p:cNvSpPr txBox="1"/>
            <p:nvPr/>
          </p:nvSpPr>
          <p:spPr>
            <a:xfrm>
              <a:off x="4583519" y="314092"/>
              <a:ext cx="728960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4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</p:grp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9CC03388-CC35-67C2-E708-EE7E9A840D51}"/>
              </a:ext>
            </a:extLst>
          </p:cNvPr>
          <p:cNvSpPr txBox="1"/>
          <p:nvPr/>
        </p:nvSpPr>
        <p:spPr>
          <a:xfrm>
            <a:off x="221441" y="2137844"/>
            <a:ext cx="81185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2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81EA343B-0365-AF34-3765-5BA5F1550F1A}"/>
              </a:ext>
            </a:extLst>
          </p:cNvPr>
          <p:cNvSpPr/>
          <p:nvPr/>
        </p:nvSpPr>
        <p:spPr>
          <a:xfrm>
            <a:off x="2238576" y="1819968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C1258C1E-C089-646F-81A1-5C4CA62F4D58}"/>
              </a:ext>
            </a:extLst>
          </p:cNvPr>
          <p:cNvSpPr/>
          <p:nvPr/>
        </p:nvSpPr>
        <p:spPr>
          <a:xfrm>
            <a:off x="2490077" y="2629786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484B861A-24E9-19B0-CE01-6B63288A9F4E}"/>
              </a:ext>
            </a:extLst>
          </p:cNvPr>
          <p:cNvSpPr/>
          <p:nvPr/>
        </p:nvSpPr>
        <p:spPr>
          <a:xfrm>
            <a:off x="2452596" y="2024354"/>
            <a:ext cx="74951" cy="1220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338211A9-3E36-5E0C-AEE8-2987378ABB40}"/>
              </a:ext>
            </a:extLst>
          </p:cNvPr>
          <p:cNvSpPr txBox="1"/>
          <p:nvPr/>
        </p:nvSpPr>
        <p:spPr>
          <a:xfrm>
            <a:off x="232415" y="3515317"/>
            <a:ext cx="81185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5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F87B41AF-1FBB-C7C7-2E14-811EFEEA4737}"/>
              </a:ext>
            </a:extLst>
          </p:cNvPr>
          <p:cNvSpPr/>
          <p:nvPr/>
        </p:nvSpPr>
        <p:spPr>
          <a:xfrm>
            <a:off x="2249550" y="3197441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EC02F607-13BD-4D5D-BDF2-F26BB991346D}"/>
              </a:ext>
            </a:extLst>
          </p:cNvPr>
          <p:cNvSpPr/>
          <p:nvPr/>
        </p:nvSpPr>
        <p:spPr>
          <a:xfrm>
            <a:off x="2501051" y="4007259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8750E0F8-73C0-66EE-4151-3B21DB180805}"/>
              </a:ext>
            </a:extLst>
          </p:cNvPr>
          <p:cNvSpPr/>
          <p:nvPr/>
        </p:nvSpPr>
        <p:spPr>
          <a:xfrm>
            <a:off x="2463570" y="3401827"/>
            <a:ext cx="74951" cy="1220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8E8838F1-6D8E-EC74-CEAA-7645DBC7C5D8}"/>
              </a:ext>
            </a:extLst>
          </p:cNvPr>
          <p:cNvSpPr/>
          <p:nvPr/>
        </p:nvSpPr>
        <p:spPr>
          <a:xfrm>
            <a:off x="2249128" y="4586619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EB8171F3-D315-1281-88E5-AAE891B44FFE}"/>
              </a:ext>
            </a:extLst>
          </p:cNvPr>
          <p:cNvSpPr/>
          <p:nvPr/>
        </p:nvSpPr>
        <p:spPr>
          <a:xfrm>
            <a:off x="2500629" y="5396437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67B4387C-B422-D9AD-DF6B-45B8631AD9BC}"/>
              </a:ext>
            </a:extLst>
          </p:cNvPr>
          <p:cNvSpPr/>
          <p:nvPr/>
        </p:nvSpPr>
        <p:spPr>
          <a:xfrm>
            <a:off x="2463148" y="4791005"/>
            <a:ext cx="74951" cy="1220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F0F84897-6BCF-50D0-654C-1203388C9A72}"/>
              </a:ext>
            </a:extLst>
          </p:cNvPr>
          <p:cNvSpPr txBox="1"/>
          <p:nvPr/>
        </p:nvSpPr>
        <p:spPr>
          <a:xfrm>
            <a:off x="231993" y="4904495"/>
            <a:ext cx="81185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7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72" name="正方形/長方形 71">
            <a:extLst>
              <a:ext uri="{FF2B5EF4-FFF2-40B4-BE49-F238E27FC236}">
                <a16:creationId xmlns:a16="http://schemas.microsoft.com/office/drawing/2014/main" id="{58FD8F97-D461-BD30-07B6-520C1EA3993B}"/>
              </a:ext>
            </a:extLst>
          </p:cNvPr>
          <p:cNvSpPr/>
          <p:nvPr/>
        </p:nvSpPr>
        <p:spPr>
          <a:xfrm>
            <a:off x="2249128" y="5992860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87F8C099-3E1F-76DD-1493-CB00A35488E4}"/>
              </a:ext>
            </a:extLst>
          </p:cNvPr>
          <p:cNvSpPr/>
          <p:nvPr/>
        </p:nvSpPr>
        <p:spPr>
          <a:xfrm>
            <a:off x="2500629" y="6802678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315CDCFC-7F4B-F3CE-F21F-CCBA2F813DF8}"/>
              </a:ext>
            </a:extLst>
          </p:cNvPr>
          <p:cNvSpPr/>
          <p:nvPr/>
        </p:nvSpPr>
        <p:spPr>
          <a:xfrm>
            <a:off x="2463148" y="6197246"/>
            <a:ext cx="74951" cy="1220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353DD974-7541-6C13-CACB-D8B8BDAADFD0}"/>
              </a:ext>
            </a:extLst>
          </p:cNvPr>
          <p:cNvSpPr txBox="1"/>
          <p:nvPr/>
        </p:nvSpPr>
        <p:spPr>
          <a:xfrm>
            <a:off x="231993" y="6310736"/>
            <a:ext cx="81185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9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ED2AB7CF-4679-D73D-F2E0-1D69F47C957A}"/>
              </a:ext>
            </a:extLst>
          </p:cNvPr>
          <p:cNvGrpSpPr/>
          <p:nvPr/>
        </p:nvGrpSpPr>
        <p:grpSpPr>
          <a:xfrm>
            <a:off x="1088992" y="1662026"/>
            <a:ext cx="1444228" cy="1337561"/>
            <a:chOff x="1088992" y="1704756"/>
            <a:chExt cx="1444228" cy="1337561"/>
          </a:xfrm>
        </p:grpSpPr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DEE0D2BA-C455-6396-BD7C-28E8118761FA}"/>
                </a:ext>
              </a:extLst>
            </p:cNvPr>
            <p:cNvSpPr txBox="1"/>
            <p:nvPr/>
          </p:nvSpPr>
          <p:spPr>
            <a:xfrm>
              <a:off x="1470287" y="1704756"/>
              <a:ext cx="683241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1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64" name="図 63">
              <a:extLst>
                <a:ext uri="{FF2B5EF4-FFF2-40B4-BE49-F238E27FC236}">
                  <a16:creationId xmlns:a16="http://schemas.microsoft.com/office/drawing/2014/main" id="{EDEA7D38-E468-BDBC-77A6-75187A24F3E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88992" y="1844553"/>
              <a:ext cx="1444228" cy="1197764"/>
            </a:xfrm>
            <a:prstGeom prst="rect">
              <a:avLst/>
            </a:prstGeom>
          </p:spPr>
        </p:pic>
      </p:grpSp>
      <p:grpSp>
        <p:nvGrpSpPr>
          <p:cNvPr id="80" name="グループ化 79">
            <a:extLst>
              <a:ext uri="{FF2B5EF4-FFF2-40B4-BE49-F238E27FC236}">
                <a16:creationId xmlns:a16="http://schemas.microsoft.com/office/drawing/2014/main" id="{27CEE8D8-5902-E5D0-0258-A1C7052E1924}"/>
              </a:ext>
            </a:extLst>
          </p:cNvPr>
          <p:cNvGrpSpPr/>
          <p:nvPr/>
        </p:nvGrpSpPr>
        <p:grpSpPr>
          <a:xfrm>
            <a:off x="2639896" y="1662026"/>
            <a:ext cx="1444228" cy="1306896"/>
            <a:chOff x="2639896" y="1704756"/>
            <a:chExt cx="1444228" cy="1306896"/>
          </a:xfrm>
        </p:grpSpPr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3FEF592B-A910-832B-C65D-B0DE042B193F}"/>
                </a:ext>
              </a:extLst>
            </p:cNvPr>
            <p:cNvSpPr txBox="1"/>
            <p:nvPr/>
          </p:nvSpPr>
          <p:spPr>
            <a:xfrm>
              <a:off x="3028191" y="1704756"/>
              <a:ext cx="683241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3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66" name="図 65">
              <a:extLst>
                <a:ext uri="{FF2B5EF4-FFF2-40B4-BE49-F238E27FC236}">
                  <a16:creationId xmlns:a16="http://schemas.microsoft.com/office/drawing/2014/main" id="{B67A6FA8-5B10-5770-BE5B-FFD7040F5FC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39896" y="1844553"/>
              <a:ext cx="1444228" cy="1167099"/>
            </a:xfrm>
            <a:prstGeom prst="rect">
              <a:avLst/>
            </a:prstGeom>
          </p:spPr>
        </p:pic>
      </p:grpSp>
      <p:grpSp>
        <p:nvGrpSpPr>
          <p:cNvPr id="81" name="グループ化 80">
            <a:extLst>
              <a:ext uri="{FF2B5EF4-FFF2-40B4-BE49-F238E27FC236}">
                <a16:creationId xmlns:a16="http://schemas.microsoft.com/office/drawing/2014/main" id="{D855C5F8-DD41-357E-9BAE-8E6B10D0C13D}"/>
              </a:ext>
            </a:extLst>
          </p:cNvPr>
          <p:cNvGrpSpPr/>
          <p:nvPr/>
        </p:nvGrpSpPr>
        <p:grpSpPr>
          <a:xfrm>
            <a:off x="4190800" y="1656082"/>
            <a:ext cx="1425308" cy="1334257"/>
            <a:chOff x="4190800" y="1698812"/>
            <a:chExt cx="1425308" cy="1334257"/>
          </a:xfrm>
        </p:grpSpPr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E630AFFC-E4BD-1758-55F9-706270F5653E}"/>
                </a:ext>
              </a:extLst>
            </p:cNvPr>
            <p:cNvSpPr txBox="1"/>
            <p:nvPr/>
          </p:nvSpPr>
          <p:spPr>
            <a:xfrm>
              <a:off x="4586095" y="1698812"/>
              <a:ext cx="728960" cy="205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4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70" name="図 69">
              <a:extLst>
                <a:ext uri="{FF2B5EF4-FFF2-40B4-BE49-F238E27FC236}">
                  <a16:creationId xmlns:a16="http://schemas.microsoft.com/office/drawing/2014/main" id="{AC7FD684-D39D-EB82-6B79-99CAD7B2DCE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190800" y="1844553"/>
              <a:ext cx="1425308" cy="1188516"/>
            </a:xfrm>
            <a:prstGeom prst="rect">
              <a:avLst/>
            </a:prstGeom>
          </p:spPr>
        </p:pic>
      </p:grpSp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id="{D078233E-7499-1214-4C52-51ABA8795F7B}"/>
              </a:ext>
            </a:extLst>
          </p:cNvPr>
          <p:cNvGrpSpPr/>
          <p:nvPr/>
        </p:nvGrpSpPr>
        <p:grpSpPr>
          <a:xfrm>
            <a:off x="1088992" y="2997386"/>
            <a:ext cx="1444228" cy="1364764"/>
            <a:chOff x="1088992" y="2997386"/>
            <a:chExt cx="1444228" cy="1364764"/>
          </a:xfrm>
        </p:grpSpPr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0981D164-CA0C-C949-514A-E35557548C96}"/>
                </a:ext>
              </a:extLst>
            </p:cNvPr>
            <p:cNvSpPr txBox="1"/>
            <p:nvPr/>
          </p:nvSpPr>
          <p:spPr>
            <a:xfrm>
              <a:off x="1481565" y="2997386"/>
              <a:ext cx="683241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1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84" name="図 83">
              <a:extLst>
                <a:ext uri="{FF2B5EF4-FFF2-40B4-BE49-F238E27FC236}">
                  <a16:creationId xmlns:a16="http://schemas.microsoft.com/office/drawing/2014/main" id="{3443E327-9347-274C-2D8C-91637844BDF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88992" y="3173457"/>
              <a:ext cx="1444228" cy="1188693"/>
            </a:xfrm>
            <a:prstGeom prst="rect">
              <a:avLst/>
            </a:prstGeom>
          </p:spPr>
        </p:pic>
      </p:grpSp>
      <p:grpSp>
        <p:nvGrpSpPr>
          <p:cNvPr id="92" name="グループ化 91">
            <a:extLst>
              <a:ext uri="{FF2B5EF4-FFF2-40B4-BE49-F238E27FC236}">
                <a16:creationId xmlns:a16="http://schemas.microsoft.com/office/drawing/2014/main" id="{898D33A0-C6B6-3538-38D1-01B3F2CEC6F0}"/>
              </a:ext>
            </a:extLst>
          </p:cNvPr>
          <p:cNvGrpSpPr/>
          <p:nvPr/>
        </p:nvGrpSpPr>
        <p:grpSpPr>
          <a:xfrm>
            <a:off x="2654434" y="2997385"/>
            <a:ext cx="1417842" cy="1348993"/>
            <a:chOff x="2654434" y="2997385"/>
            <a:chExt cx="1417842" cy="1348993"/>
          </a:xfrm>
        </p:grpSpPr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18EB129B-1C83-C6BE-17E6-77F0D5B088E2}"/>
                </a:ext>
              </a:extLst>
            </p:cNvPr>
            <p:cNvSpPr txBox="1"/>
            <p:nvPr/>
          </p:nvSpPr>
          <p:spPr>
            <a:xfrm>
              <a:off x="3051306" y="2997385"/>
              <a:ext cx="683241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3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88" name="図 87">
              <a:extLst>
                <a:ext uri="{FF2B5EF4-FFF2-40B4-BE49-F238E27FC236}">
                  <a16:creationId xmlns:a16="http://schemas.microsoft.com/office/drawing/2014/main" id="{492F834F-ACC7-EEF1-7BB2-883EEB6A676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654434" y="3173457"/>
              <a:ext cx="1417842" cy="1172921"/>
            </a:xfrm>
            <a:prstGeom prst="rect">
              <a:avLst/>
            </a:prstGeom>
          </p:spPr>
        </p:pic>
      </p:grpSp>
      <p:grpSp>
        <p:nvGrpSpPr>
          <p:cNvPr id="93" name="グループ化 92">
            <a:extLst>
              <a:ext uri="{FF2B5EF4-FFF2-40B4-BE49-F238E27FC236}">
                <a16:creationId xmlns:a16="http://schemas.microsoft.com/office/drawing/2014/main" id="{4A940F80-6A28-0228-84F3-EDAAFDF6443D}"/>
              </a:ext>
            </a:extLst>
          </p:cNvPr>
          <p:cNvGrpSpPr/>
          <p:nvPr/>
        </p:nvGrpSpPr>
        <p:grpSpPr>
          <a:xfrm>
            <a:off x="4193490" y="2991441"/>
            <a:ext cx="1380882" cy="1356663"/>
            <a:chOff x="4193490" y="2991441"/>
            <a:chExt cx="1380882" cy="1356663"/>
          </a:xfrm>
        </p:grpSpPr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B80A9FED-67C0-9F76-34D8-701001CDCB41}"/>
                </a:ext>
              </a:extLst>
            </p:cNvPr>
            <p:cNvSpPr txBox="1"/>
            <p:nvPr/>
          </p:nvSpPr>
          <p:spPr>
            <a:xfrm>
              <a:off x="4597069" y="2991441"/>
              <a:ext cx="728960" cy="205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4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90" name="図 89">
              <a:extLst>
                <a:ext uri="{FF2B5EF4-FFF2-40B4-BE49-F238E27FC236}">
                  <a16:creationId xmlns:a16="http://schemas.microsoft.com/office/drawing/2014/main" id="{92039402-BE0D-91F7-99C0-4213FF2D009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193490" y="3173457"/>
              <a:ext cx="1380882" cy="1174647"/>
            </a:xfrm>
            <a:prstGeom prst="rect">
              <a:avLst/>
            </a:prstGeom>
          </p:spPr>
        </p:pic>
      </p:grpSp>
      <p:grpSp>
        <p:nvGrpSpPr>
          <p:cNvPr id="100" name="グループ化 99">
            <a:extLst>
              <a:ext uri="{FF2B5EF4-FFF2-40B4-BE49-F238E27FC236}">
                <a16:creationId xmlns:a16="http://schemas.microsoft.com/office/drawing/2014/main" id="{56FF3292-87B1-9D03-A284-529FBECB7A5B}"/>
              </a:ext>
            </a:extLst>
          </p:cNvPr>
          <p:cNvGrpSpPr/>
          <p:nvPr/>
        </p:nvGrpSpPr>
        <p:grpSpPr>
          <a:xfrm>
            <a:off x="1088992" y="4386564"/>
            <a:ext cx="1444228" cy="1346387"/>
            <a:chOff x="1088992" y="4386564"/>
            <a:chExt cx="1444228" cy="1346387"/>
          </a:xfrm>
        </p:grpSpPr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AC035E7C-146D-F725-1281-8778E885F693}"/>
                </a:ext>
              </a:extLst>
            </p:cNvPr>
            <p:cNvSpPr txBox="1"/>
            <p:nvPr/>
          </p:nvSpPr>
          <p:spPr>
            <a:xfrm>
              <a:off x="1481143" y="4386564"/>
              <a:ext cx="683241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1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95" name="図 94">
              <a:extLst>
                <a:ext uri="{FF2B5EF4-FFF2-40B4-BE49-F238E27FC236}">
                  <a16:creationId xmlns:a16="http://schemas.microsoft.com/office/drawing/2014/main" id="{8687C880-66AD-2D7F-DE43-9655984C803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088992" y="4545474"/>
              <a:ext cx="1444228" cy="1187477"/>
            </a:xfrm>
            <a:prstGeom prst="rect">
              <a:avLst/>
            </a:prstGeom>
          </p:spPr>
        </p:pic>
      </p:grp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1B7ABBFE-04B6-198A-5047-ABE2D2741356}"/>
              </a:ext>
            </a:extLst>
          </p:cNvPr>
          <p:cNvGrpSpPr/>
          <p:nvPr/>
        </p:nvGrpSpPr>
        <p:grpSpPr>
          <a:xfrm>
            <a:off x="2647728" y="4386563"/>
            <a:ext cx="1436196" cy="1343945"/>
            <a:chOff x="2647728" y="4386563"/>
            <a:chExt cx="1436196" cy="1343945"/>
          </a:xfrm>
        </p:grpSpPr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76E40690-2AA9-7650-DEAB-37C4E0ECBF5D}"/>
                </a:ext>
              </a:extLst>
            </p:cNvPr>
            <p:cNvSpPr txBox="1"/>
            <p:nvPr/>
          </p:nvSpPr>
          <p:spPr>
            <a:xfrm>
              <a:off x="3050884" y="4386563"/>
              <a:ext cx="683241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2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97" name="図 96">
              <a:extLst>
                <a:ext uri="{FF2B5EF4-FFF2-40B4-BE49-F238E27FC236}">
                  <a16:creationId xmlns:a16="http://schemas.microsoft.com/office/drawing/2014/main" id="{12F7F738-4A68-9CD7-50A6-A991916E7AF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647728" y="4545474"/>
              <a:ext cx="1436196" cy="1185034"/>
            </a:xfrm>
            <a:prstGeom prst="rect">
              <a:avLst/>
            </a:prstGeom>
          </p:spPr>
        </p:pic>
      </p:grp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id="{469827B7-224F-BD17-951B-DC77713D1B9B}"/>
              </a:ext>
            </a:extLst>
          </p:cNvPr>
          <p:cNvGrpSpPr/>
          <p:nvPr/>
        </p:nvGrpSpPr>
        <p:grpSpPr>
          <a:xfrm>
            <a:off x="4198433" y="4380619"/>
            <a:ext cx="1417842" cy="1349439"/>
            <a:chOff x="4198433" y="4380619"/>
            <a:chExt cx="1417842" cy="1349439"/>
          </a:xfrm>
        </p:grpSpPr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B3092628-9C3E-D443-19AE-03E1905A2E43}"/>
                </a:ext>
              </a:extLst>
            </p:cNvPr>
            <p:cNvSpPr txBox="1"/>
            <p:nvPr/>
          </p:nvSpPr>
          <p:spPr>
            <a:xfrm>
              <a:off x="4596647" y="4380619"/>
              <a:ext cx="728960" cy="205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3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99" name="図 98">
              <a:extLst>
                <a:ext uri="{FF2B5EF4-FFF2-40B4-BE49-F238E27FC236}">
                  <a16:creationId xmlns:a16="http://schemas.microsoft.com/office/drawing/2014/main" id="{16DD255A-DA0C-1D07-DB19-5DEE7096973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198433" y="4545474"/>
              <a:ext cx="1417842" cy="1184584"/>
            </a:xfrm>
            <a:prstGeom prst="rect">
              <a:avLst/>
            </a:prstGeom>
          </p:spPr>
        </p:pic>
      </p:grpSp>
      <p:grpSp>
        <p:nvGrpSpPr>
          <p:cNvPr id="109" name="グループ化 108">
            <a:extLst>
              <a:ext uri="{FF2B5EF4-FFF2-40B4-BE49-F238E27FC236}">
                <a16:creationId xmlns:a16="http://schemas.microsoft.com/office/drawing/2014/main" id="{0D55C440-AC27-A173-4CFE-0CD49B7FE5DA}"/>
              </a:ext>
            </a:extLst>
          </p:cNvPr>
          <p:cNvGrpSpPr/>
          <p:nvPr/>
        </p:nvGrpSpPr>
        <p:grpSpPr>
          <a:xfrm>
            <a:off x="1088992" y="5792805"/>
            <a:ext cx="1472758" cy="1360753"/>
            <a:chOff x="1088992" y="5792805"/>
            <a:chExt cx="1472758" cy="1360753"/>
          </a:xfrm>
        </p:grpSpPr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C1CADEA3-D63D-EECB-63E5-433899F275DB}"/>
                </a:ext>
              </a:extLst>
            </p:cNvPr>
            <p:cNvSpPr txBox="1"/>
            <p:nvPr/>
          </p:nvSpPr>
          <p:spPr>
            <a:xfrm>
              <a:off x="1481143" y="5792805"/>
              <a:ext cx="683241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1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104" name="図 103">
              <a:extLst>
                <a:ext uri="{FF2B5EF4-FFF2-40B4-BE49-F238E27FC236}">
                  <a16:creationId xmlns:a16="http://schemas.microsoft.com/office/drawing/2014/main" id="{6BB364D7-34DB-C681-093E-6E74F194DADB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088992" y="5938767"/>
              <a:ext cx="1472758" cy="1214791"/>
            </a:xfrm>
            <a:prstGeom prst="rect">
              <a:avLst/>
            </a:prstGeom>
          </p:spPr>
        </p:pic>
      </p:grpSp>
      <p:grpSp>
        <p:nvGrpSpPr>
          <p:cNvPr id="110" name="グループ化 109">
            <a:extLst>
              <a:ext uri="{FF2B5EF4-FFF2-40B4-BE49-F238E27FC236}">
                <a16:creationId xmlns:a16="http://schemas.microsoft.com/office/drawing/2014/main" id="{FBBDBAEE-0DB5-B237-1331-0C428C249A7B}"/>
              </a:ext>
            </a:extLst>
          </p:cNvPr>
          <p:cNvGrpSpPr/>
          <p:nvPr/>
        </p:nvGrpSpPr>
        <p:grpSpPr>
          <a:xfrm>
            <a:off x="2632070" y="5792804"/>
            <a:ext cx="1496043" cy="1382343"/>
            <a:chOff x="2632070" y="5792804"/>
            <a:chExt cx="1496043" cy="1382343"/>
          </a:xfrm>
        </p:grpSpPr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9D313169-7E23-1D7C-4E3B-2FF9AF3D6750}"/>
                </a:ext>
              </a:extLst>
            </p:cNvPr>
            <p:cNvSpPr txBox="1"/>
            <p:nvPr/>
          </p:nvSpPr>
          <p:spPr>
            <a:xfrm>
              <a:off x="3050884" y="5792804"/>
              <a:ext cx="683241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2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106" name="図 105">
              <a:extLst>
                <a:ext uri="{FF2B5EF4-FFF2-40B4-BE49-F238E27FC236}">
                  <a16:creationId xmlns:a16="http://schemas.microsoft.com/office/drawing/2014/main" id="{3E1CDC51-D75C-2D4B-0C7B-72E29094B951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632070" y="5938767"/>
              <a:ext cx="1496043" cy="1236380"/>
            </a:xfrm>
            <a:prstGeom prst="rect">
              <a:avLst/>
            </a:prstGeom>
          </p:spPr>
        </p:pic>
      </p:grpSp>
      <p:grpSp>
        <p:nvGrpSpPr>
          <p:cNvPr id="111" name="グループ化 110">
            <a:extLst>
              <a:ext uri="{FF2B5EF4-FFF2-40B4-BE49-F238E27FC236}">
                <a16:creationId xmlns:a16="http://schemas.microsoft.com/office/drawing/2014/main" id="{9B99D723-D464-9019-9CB6-5BFF3BEAE166}"/>
              </a:ext>
            </a:extLst>
          </p:cNvPr>
          <p:cNvGrpSpPr/>
          <p:nvPr/>
        </p:nvGrpSpPr>
        <p:grpSpPr>
          <a:xfrm>
            <a:off x="4198433" y="5786860"/>
            <a:ext cx="1496269" cy="1378048"/>
            <a:chOff x="4198433" y="5786860"/>
            <a:chExt cx="1496269" cy="1378048"/>
          </a:xfrm>
        </p:grpSpPr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600847EC-A18E-0E83-AED8-9AC9098F112B}"/>
                </a:ext>
              </a:extLst>
            </p:cNvPr>
            <p:cNvSpPr txBox="1"/>
            <p:nvPr/>
          </p:nvSpPr>
          <p:spPr>
            <a:xfrm>
              <a:off x="4596647" y="5786860"/>
              <a:ext cx="728960" cy="205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3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pic>
          <p:nvPicPr>
            <p:cNvPr id="108" name="図 107">
              <a:extLst>
                <a:ext uri="{FF2B5EF4-FFF2-40B4-BE49-F238E27FC236}">
                  <a16:creationId xmlns:a16="http://schemas.microsoft.com/office/drawing/2014/main" id="{035AB797-F1C4-926F-645E-C279FBF5A7C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198433" y="5938767"/>
              <a:ext cx="1496269" cy="122614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967471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67A3EE27-FF7B-F016-4FBB-45FC445685AB}"/>
              </a:ext>
            </a:extLst>
          </p:cNvPr>
          <p:cNvSpPr/>
          <p:nvPr/>
        </p:nvSpPr>
        <p:spPr>
          <a:xfrm>
            <a:off x="2481531" y="641864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81EA343B-0365-AF34-3765-5BA5F1550F1A}"/>
              </a:ext>
            </a:extLst>
          </p:cNvPr>
          <p:cNvSpPr/>
          <p:nvPr/>
        </p:nvSpPr>
        <p:spPr>
          <a:xfrm>
            <a:off x="2230030" y="1900814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0B4FDE15-F329-D12F-F9F9-4E9441463A67}"/>
              </a:ext>
            </a:extLst>
          </p:cNvPr>
          <p:cNvSpPr/>
          <p:nvPr/>
        </p:nvSpPr>
        <p:spPr>
          <a:xfrm>
            <a:off x="2462970" y="1278779"/>
            <a:ext cx="56031" cy="1235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C1258C1E-C089-646F-81A1-5C4CA62F4D58}"/>
              </a:ext>
            </a:extLst>
          </p:cNvPr>
          <p:cNvSpPr/>
          <p:nvPr/>
        </p:nvSpPr>
        <p:spPr>
          <a:xfrm>
            <a:off x="2481531" y="2710632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484B861A-24E9-19B0-CE01-6B63288A9F4E}"/>
              </a:ext>
            </a:extLst>
          </p:cNvPr>
          <p:cNvSpPr/>
          <p:nvPr/>
        </p:nvSpPr>
        <p:spPr>
          <a:xfrm>
            <a:off x="2444050" y="2105200"/>
            <a:ext cx="74951" cy="1220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5008490-8FCE-DF93-B0FC-1D864225F7D5}"/>
              </a:ext>
            </a:extLst>
          </p:cNvPr>
          <p:cNvSpPr txBox="1"/>
          <p:nvPr/>
        </p:nvSpPr>
        <p:spPr>
          <a:xfrm>
            <a:off x="358858" y="795449"/>
            <a:ext cx="1603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Cluster3 in Patient1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9D440BB-E62B-B2EF-F4AC-B20982950E0C}"/>
              </a:ext>
            </a:extLst>
          </p:cNvPr>
          <p:cNvSpPr txBox="1"/>
          <p:nvPr/>
        </p:nvSpPr>
        <p:spPr>
          <a:xfrm>
            <a:off x="358858" y="4540694"/>
            <a:ext cx="1603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Cluster2 in Patient2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2BB2E12-A254-3837-DC86-046966E6F2B4}"/>
              </a:ext>
            </a:extLst>
          </p:cNvPr>
          <p:cNvSpPr txBox="1"/>
          <p:nvPr/>
        </p:nvSpPr>
        <p:spPr>
          <a:xfrm>
            <a:off x="358858" y="2667801"/>
            <a:ext cx="1603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Cluster3 in Patient1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DCC9D92-3B2A-3AFC-0E81-576B02BE4B4A}"/>
              </a:ext>
            </a:extLst>
          </p:cNvPr>
          <p:cNvSpPr txBox="1"/>
          <p:nvPr/>
        </p:nvSpPr>
        <p:spPr>
          <a:xfrm>
            <a:off x="358858" y="6413316"/>
            <a:ext cx="1603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Cluster2 in Patient2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99B41B3-4168-A4BB-4E76-C9534E6B1445}"/>
              </a:ext>
            </a:extLst>
          </p:cNvPr>
          <p:cNvSpPr txBox="1"/>
          <p:nvPr/>
        </p:nvSpPr>
        <p:spPr>
          <a:xfrm>
            <a:off x="199308" y="7455694"/>
            <a:ext cx="26977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Black" panose="020B0A04020102020204" pitchFamily="34" charset="0"/>
              </a:rPr>
              <a:t>Supplementary Figure.2</a:t>
            </a:r>
            <a:endParaRPr lang="ja-JP" altLang="en-US" sz="1400" dirty="0">
              <a:latin typeface="Arial Black" panose="020B0A040201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E00FB510-BBB2-EB88-3A27-8BC988FD8B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4823" y="-709"/>
            <a:ext cx="3999843" cy="1838536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44005024-0D93-6B93-CB3D-3520B7A6C0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8827" y="1871373"/>
            <a:ext cx="3373377" cy="1839077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501A45AA-8E05-EBB3-6973-840A87B6251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68827" y="3743996"/>
            <a:ext cx="3373377" cy="1839617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0116B254-6D3C-29E7-65C7-22365B48034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68827" y="5617159"/>
            <a:ext cx="3373377" cy="18385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81196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99B41B3-4168-A4BB-4E76-C9534E6B1445}"/>
              </a:ext>
            </a:extLst>
          </p:cNvPr>
          <p:cNvSpPr txBox="1"/>
          <p:nvPr/>
        </p:nvSpPr>
        <p:spPr>
          <a:xfrm>
            <a:off x="199307" y="7425714"/>
            <a:ext cx="26806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Black" panose="020B0A04020102020204" pitchFamily="34" charset="0"/>
              </a:rPr>
              <a:t>Supplementary Figure.3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67A3EE27-FF7B-F016-4FBB-45FC445685AB}"/>
              </a:ext>
            </a:extLst>
          </p:cNvPr>
          <p:cNvSpPr/>
          <p:nvPr/>
        </p:nvSpPr>
        <p:spPr>
          <a:xfrm>
            <a:off x="2490077" y="421559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81EA343B-0365-AF34-3765-5BA5F1550F1A}"/>
              </a:ext>
            </a:extLst>
          </p:cNvPr>
          <p:cNvSpPr/>
          <p:nvPr/>
        </p:nvSpPr>
        <p:spPr>
          <a:xfrm>
            <a:off x="2238576" y="1833465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0B4FDE15-F329-D12F-F9F9-4E9441463A67}"/>
              </a:ext>
            </a:extLst>
          </p:cNvPr>
          <p:cNvSpPr/>
          <p:nvPr/>
        </p:nvSpPr>
        <p:spPr>
          <a:xfrm>
            <a:off x="2471516" y="1058474"/>
            <a:ext cx="56031" cy="1235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C1258C1E-C089-646F-81A1-5C4CA62F4D58}"/>
              </a:ext>
            </a:extLst>
          </p:cNvPr>
          <p:cNvSpPr/>
          <p:nvPr/>
        </p:nvSpPr>
        <p:spPr>
          <a:xfrm>
            <a:off x="2490077" y="2643283"/>
            <a:ext cx="45719" cy="59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484B861A-24E9-19B0-CE01-6B63288A9F4E}"/>
              </a:ext>
            </a:extLst>
          </p:cNvPr>
          <p:cNvSpPr/>
          <p:nvPr/>
        </p:nvSpPr>
        <p:spPr>
          <a:xfrm>
            <a:off x="2452596" y="2037851"/>
            <a:ext cx="74951" cy="1220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5008490-8FCE-DF93-B0FC-1D864225F7D5}"/>
              </a:ext>
            </a:extLst>
          </p:cNvPr>
          <p:cNvSpPr txBox="1"/>
          <p:nvPr/>
        </p:nvSpPr>
        <p:spPr>
          <a:xfrm>
            <a:off x="364417" y="811177"/>
            <a:ext cx="1603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Cluster2 in Patient5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0F31A19-1695-1B31-2DEC-C826736F957B}"/>
              </a:ext>
            </a:extLst>
          </p:cNvPr>
          <p:cNvSpPr txBox="1"/>
          <p:nvPr/>
        </p:nvSpPr>
        <p:spPr>
          <a:xfrm>
            <a:off x="364417" y="2644277"/>
            <a:ext cx="1603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Cluster2 in Patient5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14BD194-956C-FB60-0E2B-B87BAF431402}"/>
              </a:ext>
            </a:extLst>
          </p:cNvPr>
          <p:cNvSpPr txBox="1"/>
          <p:nvPr/>
        </p:nvSpPr>
        <p:spPr>
          <a:xfrm>
            <a:off x="364417" y="4477445"/>
            <a:ext cx="1603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Cluster4 in Patient7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38E0417-982D-082F-4326-5C711ECDA6BC}"/>
              </a:ext>
            </a:extLst>
          </p:cNvPr>
          <p:cNvSpPr txBox="1"/>
          <p:nvPr/>
        </p:nvSpPr>
        <p:spPr>
          <a:xfrm>
            <a:off x="364417" y="6311474"/>
            <a:ext cx="1603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Cluster4 in Patient9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715C88B5-03F8-5486-943C-52FF61DEB3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1933" y="35109"/>
            <a:ext cx="3292620" cy="1798356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B206DB9-2111-03AF-8BB3-00C1B8D7FE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1934" y="1868275"/>
            <a:ext cx="3304057" cy="1798225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45D22CD9-2B14-AB60-4E23-B5EBC31412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1933" y="3701310"/>
            <a:ext cx="3292620" cy="179849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CB8CBD36-5252-F54A-3EEA-83B5AC6A98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01933" y="5534611"/>
            <a:ext cx="3292620" cy="17999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81649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1CACBFB-11F3-FF44-A642-6DD8B062EE2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FF74B9F-77B9-DCFD-DDA1-8788A68A1C8F}"/>
              </a:ext>
            </a:extLst>
          </p:cNvPr>
          <p:cNvSpPr txBox="1"/>
          <p:nvPr/>
        </p:nvSpPr>
        <p:spPr>
          <a:xfrm>
            <a:off x="157784" y="7395418"/>
            <a:ext cx="2566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Black" panose="020B0A04020102020204" pitchFamily="34" charset="0"/>
              </a:rPr>
              <a:t>Supplementary Figure.4</a:t>
            </a:r>
            <a:endParaRPr lang="ja-JP" altLang="en-US" sz="1400" dirty="0">
              <a:latin typeface="Arial Black" panose="020B0A040201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F859F402-B1BD-E455-EC86-D4CC6ED6E9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50" y="921370"/>
            <a:ext cx="5737538" cy="59296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13351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4E975CB-0D00-F18E-73FB-8AF75F52FD4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677F59D-C1F4-AE40-CAFC-544F28D9CACD}"/>
              </a:ext>
            </a:extLst>
          </p:cNvPr>
          <p:cNvSpPr txBox="1"/>
          <p:nvPr/>
        </p:nvSpPr>
        <p:spPr>
          <a:xfrm>
            <a:off x="157784" y="7395418"/>
            <a:ext cx="2566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Black" panose="020B0A04020102020204" pitchFamily="34" charset="0"/>
              </a:rPr>
              <a:t>Supplementary Figure.5</a:t>
            </a:r>
            <a:endParaRPr lang="ja-JP" altLang="en-US" sz="1400" dirty="0">
              <a:latin typeface="Arial Black" panose="020B0A04020102020204" pitchFamily="34" charset="0"/>
            </a:endParaRPr>
          </a:p>
        </p:txBody>
      </p: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A0EC0720-E1AA-FDA2-FC9F-336073F5958B}"/>
              </a:ext>
            </a:extLst>
          </p:cNvPr>
          <p:cNvGrpSpPr/>
          <p:nvPr/>
        </p:nvGrpSpPr>
        <p:grpSpPr>
          <a:xfrm>
            <a:off x="1584845" y="107791"/>
            <a:ext cx="3048547" cy="3692217"/>
            <a:chOff x="1511316" y="261679"/>
            <a:chExt cx="3382105" cy="3995528"/>
          </a:xfrm>
        </p:grpSpPr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D4160628-62B0-69DC-27A2-B7D6E617FC5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49873" y="475685"/>
              <a:ext cx="2718491" cy="3781522"/>
            </a:xfrm>
            <a:prstGeom prst="rect">
              <a:avLst/>
            </a:prstGeom>
          </p:spPr>
        </p:pic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29261745-D150-8585-B067-B405402C8F7D}"/>
                </a:ext>
              </a:extLst>
            </p:cNvPr>
            <p:cNvSpPr txBox="1"/>
            <p:nvPr/>
          </p:nvSpPr>
          <p:spPr>
            <a:xfrm>
              <a:off x="1511316" y="748798"/>
              <a:ext cx="2372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 Black" panose="020B0A04020102020204" pitchFamily="34" charset="0"/>
                </a:rPr>
                <a:t>1</a:t>
              </a:r>
              <a:endParaRPr kumimoji="1" lang="ja-JP" altLang="en-US" sz="1200" dirty="0">
                <a:latin typeface="Arial Black" panose="020B0A040201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E31ABE89-B4D2-EACE-87AD-386219C04F94}"/>
                </a:ext>
              </a:extLst>
            </p:cNvPr>
            <p:cNvSpPr txBox="1"/>
            <p:nvPr/>
          </p:nvSpPr>
          <p:spPr>
            <a:xfrm>
              <a:off x="1511316" y="1773507"/>
              <a:ext cx="3473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 Black" panose="020B0A04020102020204" pitchFamily="34" charset="0"/>
                </a:rPr>
                <a:t>2</a:t>
              </a:r>
              <a:endParaRPr kumimoji="1" lang="ja-JP" altLang="en-US" sz="1200" dirty="0">
                <a:latin typeface="Arial Black" panose="020B0A040201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DBBBE561-0BB9-03A9-E9F6-F717FF5B81FD}"/>
                </a:ext>
              </a:extLst>
            </p:cNvPr>
            <p:cNvSpPr txBox="1"/>
            <p:nvPr/>
          </p:nvSpPr>
          <p:spPr>
            <a:xfrm>
              <a:off x="1511316" y="2854372"/>
              <a:ext cx="3774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 Black" panose="020B0A04020102020204" pitchFamily="34" charset="0"/>
                </a:rPr>
                <a:t>3</a:t>
              </a:r>
              <a:endParaRPr kumimoji="1" lang="ja-JP" altLang="en-US" sz="1200" dirty="0">
                <a:latin typeface="Arial Black" panose="020B0A040201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43923289-60E5-C338-D5E2-454F279D2FB5}"/>
                </a:ext>
              </a:extLst>
            </p:cNvPr>
            <p:cNvSpPr txBox="1"/>
            <p:nvPr/>
          </p:nvSpPr>
          <p:spPr>
            <a:xfrm>
              <a:off x="1511316" y="3678251"/>
              <a:ext cx="4375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 Black" panose="020B0A04020102020204" pitchFamily="34" charset="0"/>
                </a:rPr>
                <a:t>4</a:t>
              </a:r>
              <a:endParaRPr kumimoji="1" lang="ja-JP" altLang="en-US" sz="1200" dirty="0">
                <a:latin typeface="Arial Black" panose="020B0A040201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F8FE9FA1-3485-1CE5-287D-1DD54EDE927C}"/>
                </a:ext>
              </a:extLst>
            </p:cNvPr>
            <p:cNvSpPr txBox="1"/>
            <p:nvPr/>
          </p:nvSpPr>
          <p:spPr>
            <a:xfrm>
              <a:off x="1798669" y="261679"/>
              <a:ext cx="843431" cy="2831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b="1" dirty="0"/>
                <a:t>Control_1</a:t>
              </a:r>
              <a:endParaRPr kumimoji="1" lang="ja-JP" altLang="en-US" sz="1100" b="1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6A1DF927-011C-14E9-76A9-8CED0F284E6F}"/>
                </a:ext>
              </a:extLst>
            </p:cNvPr>
            <p:cNvSpPr txBox="1"/>
            <p:nvPr/>
          </p:nvSpPr>
          <p:spPr>
            <a:xfrm>
              <a:off x="2683022" y="261679"/>
              <a:ext cx="843431" cy="2831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b="1" dirty="0"/>
                <a:t>Control_2</a:t>
              </a:r>
              <a:endParaRPr kumimoji="1" lang="ja-JP" altLang="en-US" sz="1100" b="1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C1F58C43-6180-2C15-6BE3-BECE73B38FF3}"/>
                </a:ext>
              </a:extLst>
            </p:cNvPr>
            <p:cNvSpPr txBox="1"/>
            <p:nvPr/>
          </p:nvSpPr>
          <p:spPr>
            <a:xfrm>
              <a:off x="3567374" y="261679"/>
              <a:ext cx="843431" cy="2831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b="1" dirty="0"/>
                <a:t>Control_3</a:t>
              </a:r>
              <a:endParaRPr kumimoji="1" lang="ja-JP" altLang="en-US" sz="1100" b="1" dirty="0"/>
            </a:p>
          </p:txBody>
        </p:sp>
        <p:pic>
          <p:nvPicPr>
            <p:cNvPr id="28" name="図 27">
              <a:extLst>
                <a:ext uri="{FF2B5EF4-FFF2-40B4-BE49-F238E27FC236}">
                  <a16:creationId xmlns:a16="http://schemas.microsoft.com/office/drawing/2014/main" id="{F7C58719-509C-B00E-8A6B-76D9DAC4997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520420" y="1912721"/>
              <a:ext cx="373001" cy="907451"/>
            </a:xfrm>
            <a:prstGeom prst="rect">
              <a:avLst/>
            </a:prstGeom>
          </p:spPr>
        </p:pic>
      </p:grp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B16841B-9E9F-72FA-96AC-D02AF7D3DE01}"/>
              </a:ext>
            </a:extLst>
          </p:cNvPr>
          <p:cNvSpPr txBox="1"/>
          <p:nvPr/>
        </p:nvSpPr>
        <p:spPr>
          <a:xfrm>
            <a:off x="474820" y="107791"/>
            <a:ext cx="547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 Black" panose="020B0A04020102020204" pitchFamily="34" charset="0"/>
              </a:rPr>
              <a:t>(A)</a:t>
            </a:r>
            <a:endParaRPr kumimoji="1" lang="ja-JP" altLang="en-US" sz="1400" dirty="0">
              <a:latin typeface="Arial Black" panose="020B0A040201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64EAC23-024B-0F4E-BC24-8ED2AB96C62A}"/>
              </a:ext>
            </a:extLst>
          </p:cNvPr>
          <p:cNvSpPr txBox="1"/>
          <p:nvPr/>
        </p:nvSpPr>
        <p:spPr>
          <a:xfrm>
            <a:off x="488171" y="4048681"/>
            <a:ext cx="5211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 Black" panose="020B0A04020102020204" pitchFamily="34" charset="0"/>
              </a:rPr>
              <a:t>(B)</a:t>
            </a:r>
            <a:endParaRPr kumimoji="1" lang="ja-JP" altLang="en-US" sz="1400" dirty="0">
              <a:latin typeface="Arial Black" panose="020B0A04020102020204" pitchFamily="34" charset="0"/>
            </a:endParaRPr>
          </a:p>
        </p:txBody>
      </p: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1170E600-7918-7D4A-CF02-A2A48DC08055}"/>
              </a:ext>
            </a:extLst>
          </p:cNvPr>
          <p:cNvGrpSpPr/>
          <p:nvPr/>
        </p:nvGrpSpPr>
        <p:grpSpPr>
          <a:xfrm>
            <a:off x="1447969" y="4195899"/>
            <a:ext cx="3322299" cy="2773305"/>
            <a:chOff x="1447969" y="4195899"/>
            <a:chExt cx="3322299" cy="2773305"/>
          </a:xfrm>
        </p:grpSpPr>
        <p:pic>
          <p:nvPicPr>
            <p:cNvPr id="37" name="Picture 4">
              <a:extLst>
                <a:ext uri="{FF2B5EF4-FFF2-40B4-BE49-F238E27FC236}">
                  <a16:creationId xmlns:a16="http://schemas.microsoft.com/office/drawing/2014/main" id="{C1C8FDD9-807A-F053-5760-F567CCDD00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7969" y="4202570"/>
              <a:ext cx="3322299" cy="2766634"/>
            </a:xfrm>
            <a:prstGeom prst="rect">
              <a:avLst/>
            </a:prstGeom>
          </p:spPr>
        </p:pic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5299CB04-4349-83C0-D728-153608CD04E4}"/>
                </a:ext>
              </a:extLst>
            </p:cNvPr>
            <p:cNvSpPr/>
            <p:nvPr/>
          </p:nvSpPr>
          <p:spPr>
            <a:xfrm>
              <a:off x="1925108" y="4226222"/>
              <a:ext cx="615725" cy="13023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6BB949C1-2A8B-2151-45E2-E29A5CE1044E}"/>
                </a:ext>
              </a:extLst>
            </p:cNvPr>
            <p:cNvSpPr txBox="1"/>
            <p:nvPr/>
          </p:nvSpPr>
          <p:spPr>
            <a:xfrm>
              <a:off x="1925108" y="4195899"/>
              <a:ext cx="67193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1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B8925BDC-BBDD-A94F-91BC-F1803911B650}"/>
                </a:ext>
              </a:extLst>
            </p:cNvPr>
            <p:cNvSpPr/>
            <p:nvPr/>
          </p:nvSpPr>
          <p:spPr>
            <a:xfrm>
              <a:off x="3560164" y="4226222"/>
              <a:ext cx="615725" cy="13023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0FB8C1CA-47BC-049D-BFF2-04E863EE7EF4}"/>
                </a:ext>
              </a:extLst>
            </p:cNvPr>
            <p:cNvSpPr txBox="1"/>
            <p:nvPr/>
          </p:nvSpPr>
          <p:spPr>
            <a:xfrm>
              <a:off x="3537989" y="4195899"/>
              <a:ext cx="67193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2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9985AF94-813B-C540-A4EE-2059CC924FA4}"/>
                </a:ext>
              </a:extLst>
            </p:cNvPr>
            <p:cNvSpPr/>
            <p:nvPr/>
          </p:nvSpPr>
          <p:spPr>
            <a:xfrm>
              <a:off x="1925108" y="5585887"/>
              <a:ext cx="615725" cy="1732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8A579C27-A687-A51E-598B-D2C2BD532065}"/>
                </a:ext>
              </a:extLst>
            </p:cNvPr>
            <p:cNvSpPr txBox="1"/>
            <p:nvPr/>
          </p:nvSpPr>
          <p:spPr>
            <a:xfrm>
              <a:off x="1925108" y="5585933"/>
              <a:ext cx="67193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3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7E053D69-3C05-918C-B4F3-78136A70FDB0}"/>
                </a:ext>
              </a:extLst>
            </p:cNvPr>
            <p:cNvSpPr/>
            <p:nvPr/>
          </p:nvSpPr>
          <p:spPr>
            <a:xfrm>
              <a:off x="3560164" y="5572467"/>
              <a:ext cx="615725" cy="1732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20EFDE38-C078-0AF3-86D1-460649491B0D}"/>
                </a:ext>
              </a:extLst>
            </p:cNvPr>
            <p:cNvSpPr txBox="1"/>
            <p:nvPr/>
          </p:nvSpPr>
          <p:spPr>
            <a:xfrm>
              <a:off x="3537989" y="5585933"/>
              <a:ext cx="67193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Arial Black" panose="020B0A04020102020204" pitchFamily="34" charset="0"/>
                </a:rPr>
                <a:t>Cluster_4</a:t>
              </a:r>
              <a:endParaRPr kumimoji="1" lang="ja-JP" altLang="en-US" sz="700" dirty="0">
                <a:latin typeface="Arial Black" panose="020B0A040201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628721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C6D907-2D0B-B311-1D92-D7E25EEB5DB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E051D3F-3C14-05EA-C8FE-4852EF7B9778}"/>
              </a:ext>
            </a:extLst>
          </p:cNvPr>
          <p:cNvSpPr txBox="1"/>
          <p:nvPr/>
        </p:nvSpPr>
        <p:spPr>
          <a:xfrm>
            <a:off x="157784" y="7395418"/>
            <a:ext cx="2566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Black" panose="020B0A04020102020204" pitchFamily="34" charset="0"/>
              </a:rPr>
              <a:t>Supplementary Figure.6</a:t>
            </a:r>
            <a:endParaRPr lang="ja-JP" altLang="en-US" sz="1400" dirty="0">
              <a:latin typeface="Arial Black" panose="020B0A040201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547FC6E-9BD8-5C91-24E6-F7BC31879242}"/>
              </a:ext>
            </a:extLst>
          </p:cNvPr>
          <p:cNvSpPr txBox="1"/>
          <p:nvPr/>
        </p:nvSpPr>
        <p:spPr>
          <a:xfrm>
            <a:off x="735659" y="315642"/>
            <a:ext cx="303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 Black" panose="020B0A04020102020204" pitchFamily="34" charset="0"/>
              </a:rPr>
              <a:t>Cluster2 (downregulated on relapse)</a:t>
            </a:r>
            <a:endParaRPr lang="ja-JP" altLang="en-US" sz="1000" b="1" dirty="0">
              <a:latin typeface="Arial Black" panose="020B0A040201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35C60046-58FD-521A-B61C-340DEC2CE8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82405" y="950963"/>
            <a:ext cx="1846412" cy="1600001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C6293B3-E5B9-8CF6-A6D1-61198C3A794C}"/>
              </a:ext>
            </a:extLst>
          </p:cNvPr>
          <p:cNvSpPr txBox="1"/>
          <p:nvPr/>
        </p:nvSpPr>
        <p:spPr>
          <a:xfrm>
            <a:off x="767824" y="701041"/>
            <a:ext cx="769779" cy="253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1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D43D29A-0418-85D9-3FF9-CDFCAC9F1CD3}"/>
              </a:ext>
            </a:extLst>
          </p:cNvPr>
          <p:cNvSpPr txBox="1"/>
          <p:nvPr/>
        </p:nvSpPr>
        <p:spPr>
          <a:xfrm>
            <a:off x="2724230" y="701041"/>
            <a:ext cx="7697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2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880C44D-B6C8-DDD8-7C8E-FF9E6C226325}"/>
              </a:ext>
            </a:extLst>
          </p:cNvPr>
          <p:cNvSpPr txBox="1"/>
          <p:nvPr/>
        </p:nvSpPr>
        <p:spPr>
          <a:xfrm>
            <a:off x="4620722" y="701041"/>
            <a:ext cx="769779" cy="253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3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15CEE0D4-C3C8-4881-B7DE-2FCD53DACC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986" y="950963"/>
            <a:ext cx="1847455" cy="1600001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354D466D-DA96-2994-E5C2-2FE5F9B060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85913" y="954586"/>
            <a:ext cx="1846412" cy="1592755"/>
          </a:xfrm>
          <a:prstGeom prst="rect">
            <a:avLst/>
          </a:prstGeom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E94C3A7-51ED-7386-2018-DA5B5521E54F}"/>
              </a:ext>
            </a:extLst>
          </p:cNvPr>
          <p:cNvSpPr txBox="1"/>
          <p:nvPr/>
        </p:nvSpPr>
        <p:spPr>
          <a:xfrm>
            <a:off x="754508" y="2873097"/>
            <a:ext cx="7964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4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4044BA7-657A-01FC-A82F-21880BDFFB4D}"/>
              </a:ext>
            </a:extLst>
          </p:cNvPr>
          <p:cNvSpPr txBox="1"/>
          <p:nvPr/>
        </p:nvSpPr>
        <p:spPr>
          <a:xfrm>
            <a:off x="2710914" y="2873097"/>
            <a:ext cx="7964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5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ADA9E7B-1B71-905C-A104-9886DE6DA7DF}"/>
              </a:ext>
            </a:extLst>
          </p:cNvPr>
          <p:cNvSpPr txBox="1"/>
          <p:nvPr/>
        </p:nvSpPr>
        <p:spPr>
          <a:xfrm>
            <a:off x="4607405" y="2874104"/>
            <a:ext cx="796412" cy="24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6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C91530FD-E841-F627-E5DA-C8512315DE8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8986" y="3068180"/>
            <a:ext cx="1847455" cy="1636039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1417EA36-54C4-ED80-DFC9-486811B0E6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85913" y="3068180"/>
            <a:ext cx="1846412" cy="1636039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2A7F7120-E30D-ADC8-EEA2-65AA073BC39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82405" y="3095560"/>
            <a:ext cx="1846412" cy="1581278"/>
          </a:xfrm>
          <a:prstGeom prst="rect">
            <a:avLst/>
          </a:prstGeom>
        </p:spPr>
      </p:pic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2515042D-0175-0486-C3E5-584C1D071691}"/>
              </a:ext>
            </a:extLst>
          </p:cNvPr>
          <p:cNvSpPr txBox="1"/>
          <p:nvPr/>
        </p:nvSpPr>
        <p:spPr>
          <a:xfrm>
            <a:off x="755422" y="5026353"/>
            <a:ext cx="7945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7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1E2F4B9-B0BE-86FE-1D67-8287C883577C}"/>
              </a:ext>
            </a:extLst>
          </p:cNvPr>
          <p:cNvSpPr txBox="1"/>
          <p:nvPr/>
        </p:nvSpPr>
        <p:spPr>
          <a:xfrm>
            <a:off x="4608320" y="5026353"/>
            <a:ext cx="794582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9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1A2513A-117D-7DCB-6F5F-37C7685797CB}"/>
              </a:ext>
            </a:extLst>
          </p:cNvPr>
          <p:cNvSpPr txBox="1"/>
          <p:nvPr/>
        </p:nvSpPr>
        <p:spPr>
          <a:xfrm>
            <a:off x="2711828" y="5026353"/>
            <a:ext cx="794582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8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B1D4DA7A-5B6F-EDE8-7EE8-CC4EDCDE08D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8986" y="5255228"/>
            <a:ext cx="1847455" cy="1636039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0A83CFC6-A0E3-5273-90C5-090BF79C757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85913" y="5272572"/>
            <a:ext cx="1846412" cy="1601351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A6D6BDF2-965C-0D65-E2E4-E5FAD7FEF01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82405" y="5255228"/>
            <a:ext cx="1846412" cy="1636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31191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B662CE1-8F77-E429-9AE2-5188B50CF99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DB047DF-9962-9569-E56C-A189782BA8AB}"/>
              </a:ext>
            </a:extLst>
          </p:cNvPr>
          <p:cNvSpPr txBox="1"/>
          <p:nvPr/>
        </p:nvSpPr>
        <p:spPr>
          <a:xfrm>
            <a:off x="162914" y="7408027"/>
            <a:ext cx="2663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Black" panose="020B0A04020102020204" pitchFamily="34" charset="0"/>
              </a:rPr>
              <a:t>Supplementary Figure.7</a:t>
            </a:r>
            <a:endParaRPr lang="ja-JP" altLang="en-US" sz="1400" dirty="0">
              <a:latin typeface="Arial Black" panose="020B0A040201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601049C-DF61-C79C-9FF5-4F9417CA2D2E}"/>
              </a:ext>
            </a:extLst>
          </p:cNvPr>
          <p:cNvSpPr txBox="1"/>
          <p:nvPr/>
        </p:nvSpPr>
        <p:spPr>
          <a:xfrm>
            <a:off x="781455" y="356568"/>
            <a:ext cx="303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 Black" panose="020B0A04020102020204" pitchFamily="34" charset="0"/>
              </a:rPr>
              <a:t>Cluster3 (upregulated on relapse)</a:t>
            </a:r>
            <a:endParaRPr lang="ja-JP" altLang="en-US" sz="1000" b="1" dirty="0">
              <a:latin typeface="Arial Black" panose="020B0A040201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78CF855-BC5C-62BA-D494-72F0E0583C81}"/>
              </a:ext>
            </a:extLst>
          </p:cNvPr>
          <p:cNvSpPr txBox="1"/>
          <p:nvPr/>
        </p:nvSpPr>
        <p:spPr>
          <a:xfrm>
            <a:off x="840706" y="788222"/>
            <a:ext cx="773219" cy="254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1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C1E2F8A-0AC1-3AA0-0183-FFEE2AB59324}"/>
              </a:ext>
            </a:extLst>
          </p:cNvPr>
          <p:cNvSpPr txBox="1"/>
          <p:nvPr/>
        </p:nvSpPr>
        <p:spPr>
          <a:xfrm>
            <a:off x="2778036" y="788222"/>
            <a:ext cx="773220" cy="254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2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D65416D-8BCA-C245-5269-ED71106F2BF9}"/>
              </a:ext>
            </a:extLst>
          </p:cNvPr>
          <p:cNvSpPr txBox="1"/>
          <p:nvPr/>
        </p:nvSpPr>
        <p:spPr>
          <a:xfrm>
            <a:off x="4715205" y="792319"/>
            <a:ext cx="773221" cy="25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3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4266237E-E447-BB6B-2CF2-5842D84210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4785" y="970966"/>
            <a:ext cx="1885060" cy="1647143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19985EB6-6406-858E-F707-861AAF665B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22633" y="970966"/>
            <a:ext cx="1884025" cy="1647143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CF623518-DFE6-7BAE-7483-735D6144D7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59802" y="970966"/>
            <a:ext cx="1884025" cy="1647143"/>
          </a:xfrm>
          <a:prstGeom prst="rect">
            <a:avLst/>
          </a:prstGeom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41A9322-C98C-DDA8-51C6-EF23BC80CD2E}"/>
              </a:ext>
            </a:extLst>
          </p:cNvPr>
          <p:cNvSpPr txBox="1"/>
          <p:nvPr/>
        </p:nvSpPr>
        <p:spPr>
          <a:xfrm>
            <a:off x="856669" y="2930137"/>
            <a:ext cx="7699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4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61965CD-D8C2-32DE-8BFC-20A9FC504B1F}"/>
              </a:ext>
            </a:extLst>
          </p:cNvPr>
          <p:cNvSpPr txBox="1"/>
          <p:nvPr/>
        </p:nvSpPr>
        <p:spPr>
          <a:xfrm>
            <a:off x="2826775" y="2930136"/>
            <a:ext cx="769906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5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A773920-BD6D-0593-E868-CEAD8E55DA9F}"/>
              </a:ext>
            </a:extLst>
          </p:cNvPr>
          <p:cNvSpPr txBox="1"/>
          <p:nvPr/>
        </p:nvSpPr>
        <p:spPr>
          <a:xfrm>
            <a:off x="4745680" y="2930135"/>
            <a:ext cx="7699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6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E5E7AF58-070C-99C3-C852-6E731F539B8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3396" y="3106844"/>
            <a:ext cx="1856450" cy="1647143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B86DCEAB-5E44-9BFC-21B5-4446B507AE0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63653" y="3106844"/>
            <a:ext cx="1896150" cy="1647143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171F8029-BA90-E02D-C709-4B7A101172E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82558" y="3102240"/>
            <a:ext cx="1896150" cy="1647143"/>
          </a:xfrm>
          <a:prstGeom prst="rect">
            <a:avLst/>
          </a:prstGeom>
        </p:spPr>
      </p:pic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C651D96-AF03-001E-F078-34C2438D5543}"/>
              </a:ext>
            </a:extLst>
          </p:cNvPr>
          <p:cNvSpPr txBox="1"/>
          <p:nvPr/>
        </p:nvSpPr>
        <p:spPr>
          <a:xfrm>
            <a:off x="826756" y="5066930"/>
            <a:ext cx="787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7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3975702-1995-CDAA-F5C6-C51AEF358B49}"/>
              </a:ext>
            </a:extLst>
          </p:cNvPr>
          <p:cNvSpPr txBox="1"/>
          <p:nvPr/>
        </p:nvSpPr>
        <p:spPr>
          <a:xfrm>
            <a:off x="4722129" y="5067844"/>
            <a:ext cx="782124" cy="2443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9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261DA61-8EE5-63F8-F599-CC205872F7EA}"/>
              </a:ext>
            </a:extLst>
          </p:cNvPr>
          <p:cNvSpPr txBox="1"/>
          <p:nvPr/>
        </p:nvSpPr>
        <p:spPr>
          <a:xfrm>
            <a:off x="2769132" y="5066014"/>
            <a:ext cx="782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 Black" panose="020B0A04020102020204" pitchFamily="34" charset="0"/>
              </a:rPr>
              <a:t>Patient8</a:t>
            </a:r>
            <a:endParaRPr kumimoji="1" lang="ja-JP" altLang="en-US" sz="1000" dirty="0">
              <a:latin typeface="Arial Black" panose="020B0A04020102020204" pitchFamily="34" charset="0"/>
            </a:endParaRPr>
          </a:p>
        </p:txBody>
      </p:sp>
      <p:pic>
        <p:nvPicPr>
          <p:cNvPr id="32" name="図 31">
            <a:extLst>
              <a:ext uri="{FF2B5EF4-FFF2-40B4-BE49-F238E27FC236}">
                <a16:creationId xmlns:a16="http://schemas.microsoft.com/office/drawing/2014/main" id="{4A25CEB8-D3B7-4936-48D1-8C270000A5A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3396" y="5283137"/>
            <a:ext cx="1885060" cy="1647143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073F30A5-0BC5-0476-D999-DFA244691A2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58328" y="5283136"/>
            <a:ext cx="1879946" cy="1647143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583D792D-B42F-9F89-9612-81801020DDA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82557" y="5277191"/>
            <a:ext cx="1861269" cy="1647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07297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D2D6D28-4E06-500B-D5EE-7F0B5DF5C05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F7D74B6-EDC6-5630-D793-07D35E74FBEC}"/>
              </a:ext>
            </a:extLst>
          </p:cNvPr>
          <p:cNvSpPr txBox="1"/>
          <p:nvPr/>
        </p:nvSpPr>
        <p:spPr>
          <a:xfrm>
            <a:off x="157784" y="7395418"/>
            <a:ext cx="2566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Black" panose="020B0A04020102020204" pitchFamily="34" charset="0"/>
              </a:rPr>
              <a:t>Supplementary Figure.8</a:t>
            </a:r>
            <a:endParaRPr lang="ja-JP" altLang="en-US" sz="1400" dirty="0">
              <a:latin typeface="Arial Black" panose="020B0A040201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3C841421-850F-2AF1-3908-BBEA468A9C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49" y="921371"/>
            <a:ext cx="5737540" cy="59296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6736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397</TotalTime>
  <Words>167</Words>
  <Application>Microsoft Office PowerPoint</Application>
  <PresentationFormat>ユーザー設定</PresentationFormat>
  <Paragraphs>69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Arial</vt:lpstr>
      <vt:lpstr>Arial Black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良平 山村</dc:creator>
  <cp:lastModifiedBy>良平 山村</cp:lastModifiedBy>
  <cp:revision>194</cp:revision>
  <cp:lastPrinted>2024-06-19T01:03:56Z</cp:lastPrinted>
  <dcterms:created xsi:type="dcterms:W3CDTF">2023-12-10T14:39:51Z</dcterms:created>
  <dcterms:modified xsi:type="dcterms:W3CDTF">2025-01-14T09:46:08Z</dcterms:modified>
</cp:coreProperties>
</file>